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36968-5F96-45B0-953E-1056A729CE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34A91-923C-4420-9100-3AFF562FF3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B381A-679E-4209-B9EB-073677C8CE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158EF-070E-43E0-89AF-9A3B0F1EEC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885FE-0981-465B-8607-335E03F086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A6A07-68B3-403D-A8E9-C296622969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348F0-A13D-49D4-94C8-8120D797DE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3F88F-A876-4E23-9FEB-859FA72A80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E94D7-4708-443F-AE16-024D5D7876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76B34-6635-4E3F-8B14-09AA31B7AA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358ED-8BC8-4CE6-A7BD-874312EBA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B333D-1380-437A-8210-5D64EAC472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200E2C-0BBC-4532-8933-93DBE62D895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295280" y="1523880"/>
            <a:ext cx="6419880" cy="44769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752480" y="380880"/>
            <a:ext cx="563904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troduction of Fuzzy Heat M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 fuzzy heat map vs. traditional heat m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371600" y="5943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aditional Heat M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334120" y="5943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uzzy Heat M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676520" y="1981080"/>
            <a:ext cx="6400800" cy="337032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685800" y="609480"/>
            <a:ext cx="6934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Visualization of Biological Modules by Fuzzy Heat Map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295280" y="1523880"/>
            <a:ext cx="7086600" cy="46738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1295280" y="457200"/>
            <a:ext cx="601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Explanation of the Layout of Heat Map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371600" y="1828800"/>
            <a:ext cx="0" cy="144792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590920" y="1447920"/>
            <a:ext cx="342900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209680" y="1081080"/>
            <a:ext cx="502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notation Term associated with gene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-387000" y="1758600"/>
            <a:ext cx="281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es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1523880" y="1295280"/>
            <a:ext cx="5962680" cy="423864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1295280" y="457200"/>
            <a:ext cx="601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Explanation of the Layout of Detailed View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04T18:20:41Z</dcterms:created>
  <dc:creator>DaWei Huang</dc:creator>
  <dc:description/>
  <dc:language>en-US</dc:language>
  <cp:lastModifiedBy>DaWei Huang</cp:lastModifiedBy>
  <dcterms:modified xsi:type="dcterms:W3CDTF">2006-10-25T16:28:48Z</dcterms:modified>
  <cp:revision>4</cp:revision>
  <dc:subject/>
  <dc:title>Slide 1</dc:title>
</cp:coreProperties>
</file>